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2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1. 课题\2. 文章相关1\1. 图1\1-E\P-BCR-ABL 8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900608" y="-3267744"/>
            <a:ext cx="11305256" cy="8478942"/>
          </a:xfrm>
          <a:prstGeom prst="rect">
            <a:avLst/>
          </a:prstGeom>
          <a:noFill/>
        </p:spPr>
      </p:pic>
      <p:sp>
        <p:nvSpPr>
          <p:cNvPr id="6" name="矩形 5"/>
          <p:cNvSpPr/>
          <p:nvPr/>
        </p:nvSpPr>
        <p:spPr>
          <a:xfrm>
            <a:off x="2829519" y="151963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3563888" y="107340"/>
            <a:ext cx="6511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BaF3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4283968" y="116632"/>
            <a:ext cx="7889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BP210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5148064" y="116632"/>
            <a:ext cx="5645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32D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5652120" y="116632"/>
            <a:ext cx="6880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32DP</a:t>
            </a:r>
            <a:endParaRPr lang="zh-CN" altLang="en-US" dirty="0"/>
          </a:p>
        </p:txBody>
      </p:sp>
      <p:sp>
        <p:nvSpPr>
          <p:cNvPr id="12" name="标题 1"/>
          <p:cNvSpPr txBox="1">
            <a:spLocks/>
          </p:cNvSpPr>
          <p:nvPr/>
        </p:nvSpPr>
        <p:spPr>
          <a:xfrm>
            <a:off x="32617" y="737319"/>
            <a:ext cx="2195736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BCR-ABL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1. 课题\2. 文章相关1\1. 图1\1-E\BCR-ABL 30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1764704" y="-9382"/>
            <a:ext cx="13177464" cy="8262918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3189559" y="4256419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4" name="矩形 3"/>
          <p:cNvSpPr/>
          <p:nvPr/>
        </p:nvSpPr>
        <p:spPr>
          <a:xfrm>
            <a:off x="3923928" y="4211796"/>
            <a:ext cx="6511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BaF3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4644008" y="4221088"/>
            <a:ext cx="7889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BP210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5508104" y="4221088"/>
            <a:ext cx="5645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32D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6012160" y="4221088"/>
            <a:ext cx="6880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32DP</a:t>
            </a:r>
            <a:endParaRPr lang="zh-CN" altLang="en-US" dirty="0"/>
          </a:p>
        </p:txBody>
      </p:sp>
      <p:sp>
        <p:nvSpPr>
          <p:cNvPr id="9" name="标题 1"/>
          <p:cNvSpPr txBox="1">
            <a:spLocks/>
          </p:cNvSpPr>
          <p:nvPr/>
        </p:nvSpPr>
        <p:spPr>
          <a:xfrm>
            <a:off x="0" y="1844824"/>
            <a:ext cx="2195736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BCR-ABL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1. 课题\2. 文章相关1\1. 图1\1-E\P-RANBP3 40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2484784" y="-1395536"/>
            <a:ext cx="11797480" cy="8604702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2829519" y="151963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4" name="矩形 3"/>
          <p:cNvSpPr/>
          <p:nvPr/>
        </p:nvSpPr>
        <p:spPr>
          <a:xfrm>
            <a:off x="3563888" y="107340"/>
            <a:ext cx="6511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BaF3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4283968" y="116632"/>
            <a:ext cx="7889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BP210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5148064" y="116632"/>
            <a:ext cx="5645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32D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5652120" y="116632"/>
            <a:ext cx="6880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32DP</a:t>
            </a:r>
            <a:endParaRPr lang="zh-CN" altLang="en-US" dirty="0"/>
          </a:p>
        </p:txBody>
      </p:sp>
      <p:sp>
        <p:nvSpPr>
          <p:cNvPr id="10" name="标题 1"/>
          <p:cNvSpPr txBox="1">
            <a:spLocks/>
          </p:cNvSpPr>
          <p:nvPr/>
        </p:nvSpPr>
        <p:spPr>
          <a:xfrm>
            <a:off x="0" y="1268760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RanBP3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E:\1. 课题\2. 文章相关1\1. 图1\1-E\RANBP3 50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332531">
            <a:off x="49832" y="-1899908"/>
            <a:ext cx="10807939" cy="7542584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2829519" y="151963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4" name="矩形 3"/>
          <p:cNvSpPr/>
          <p:nvPr/>
        </p:nvSpPr>
        <p:spPr>
          <a:xfrm>
            <a:off x="3563888" y="107340"/>
            <a:ext cx="6511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BaF3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4283968" y="116632"/>
            <a:ext cx="7889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BP210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5148064" y="116632"/>
            <a:ext cx="5645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32D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5652120" y="116632"/>
            <a:ext cx="6880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32DP</a:t>
            </a:r>
            <a:endParaRPr lang="zh-CN" altLang="en-US" dirty="0"/>
          </a:p>
        </p:txBody>
      </p:sp>
      <p:sp>
        <p:nvSpPr>
          <p:cNvPr id="11" name="标题 1"/>
          <p:cNvSpPr txBox="1">
            <a:spLocks/>
          </p:cNvSpPr>
          <p:nvPr/>
        </p:nvSpPr>
        <p:spPr>
          <a:xfrm>
            <a:off x="323528" y="1628800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RanBP3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E:\1. 课题\2. 文章相关1\1. 图1\1-E\ACTIN-8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756592" y="0"/>
            <a:ext cx="11521280" cy="5715000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2829519" y="151963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4" name="矩形 3"/>
          <p:cNvSpPr/>
          <p:nvPr/>
        </p:nvSpPr>
        <p:spPr>
          <a:xfrm>
            <a:off x="3563888" y="107340"/>
            <a:ext cx="6511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BaF3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4283968" y="116632"/>
            <a:ext cx="7889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BP210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5148064" y="116632"/>
            <a:ext cx="5645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32D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5652120" y="116632"/>
            <a:ext cx="6880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32DP</a:t>
            </a:r>
            <a:endParaRPr lang="zh-CN" altLang="en-US" dirty="0"/>
          </a:p>
        </p:txBody>
      </p:sp>
      <p:sp>
        <p:nvSpPr>
          <p:cNvPr id="12" name="标题 1"/>
          <p:cNvSpPr txBox="1">
            <a:spLocks/>
          </p:cNvSpPr>
          <p:nvPr/>
        </p:nvSpPr>
        <p:spPr>
          <a:xfrm>
            <a:off x="683568" y="1772816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CTIN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30</Words>
  <Application>Microsoft Office PowerPoint</Application>
  <PresentationFormat>全屏显示(4:3)</PresentationFormat>
  <Paragraphs>30</Paragraphs>
  <Slides>5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</vt:lpstr>
      <vt:lpstr>幻灯片 1</vt:lpstr>
      <vt:lpstr>幻灯片 2</vt:lpstr>
      <vt:lpstr>幻灯片 3</vt:lpstr>
      <vt:lpstr>幻灯片 4</vt:lpstr>
      <vt:lpstr>幻灯片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IQIAN</dc:creator>
  <cp:lastModifiedBy>LIQIAN</cp:lastModifiedBy>
  <cp:revision>7</cp:revision>
  <dcterms:created xsi:type="dcterms:W3CDTF">2021-05-06T02:20:14Z</dcterms:created>
  <dcterms:modified xsi:type="dcterms:W3CDTF">2021-05-10T14:24:34Z</dcterms:modified>
</cp:coreProperties>
</file>